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3" d="100"/>
          <a:sy n="83" d="100"/>
        </p:scale>
        <p:origin x="120" y="3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MycoStone_bacteria\Artigo_NGS\Resultados_NGS\Archaea_Results_2019_03_2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percentStacked"/>
        <c:varyColors val="0"/>
        <c:ser>
          <c:idx val="0"/>
          <c:order val="0"/>
          <c:tx>
            <c:strRef>
              <c:f>Phylogeny_Percentage!$C$4:$G$4</c:f>
              <c:strCache>
                <c:ptCount val="5"/>
                <c:pt idx="0">
                  <c:v>Archaea_unclassified</c:v>
                </c:pt>
                <c:pt idx="1">
                  <c:v>Archaea_unclassified</c:v>
                </c:pt>
                <c:pt idx="2">
                  <c:v>Archaea_unclassified</c:v>
                </c:pt>
                <c:pt idx="3">
                  <c:v>Archaea_unclassified</c:v>
                </c:pt>
                <c:pt idx="4">
                  <c:v>Archaea_unclassifie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Phylogeny_Percentage!$H$3:$P$3</c:f>
              <c:strCache>
                <c:ptCount val="9"/>
                <c:pt idx="0">
                  <c:v>SV1</c:v>
                </c:pt>
                <c:pt idx="1">
                  <c:v>SV2</c:v>
                </c:pt>
                <c:pt idx="2">
                  <c:v>SV3</c:v>
                </c:pt>
                <c:pt idx="3">
                  <c:v>SV4</c:v>
                </c:pt>
                <c:pt idx="4">
                  <c:v>SV5</c:v>
                </c:pt>
                <c:pt idx="5">
                  <c:v>SV6</c:v>
                </c:pt>
                <c:pt idx="6">
                  <c:v>SV7</c:v>
                </c:pt>
                <c:pt idx="7">
                  <c:v>SV9</c:v>
                </c:pt>
                <c:pt idx="8">
                  <c:v>SV10</c:v>
                </c:pt>
              </c:strCache>
            </c:strRef>
          </c:cat>
          <c:val>
            <c:numRef>
              <c:f>Phylogeny_Percentage!$H$4:$P$4</c:f>
              <c:numCache>
                <c:formatCode>General</c:formatCode>
                <c:ptCount val="9"/>
                <c:pt idx="0">
                  <c:v>3.3904051534158333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30D-4944-B837-0373D2FBAB57}"/>
            </c:ext>
          </c:extLst>
        </c:ser>
        <c:ser>
          <c:idx val="1"/>
          <c:order val="1"/>
          <c:tx>
            <c:strRef>
              <c:f>Phylogeny_Percentage!$C$5:$G$5</c:f>
              <c:strCache>
                <c:ptCount val="5"/>
                <c:pt idx="0">
                  <c:v>Euryarchaeota</c:v>
                </c:pt>
                <c:pt idx="1">
                  <c:v>Euryarchaeota_unclassified</c:v>
                </c:pt>
                <c:pt idx="2">
                  <c:v>Euryarchaeota_unclassified</c:v>
                </c:pt>
                <c:pt idx="3">
                  <c:v>Euryarchaeota_unclassified</c:v>
                </c:pt>
                <c:pt idx="4">
                  <c:v>Euryarchaeota_unclassified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Phylogeny_Percentage!$H$3:$P$3</c:f>
              <c:strCache>
                <c:ptCount val="9"/>
                <c:pt idx="0">
                  <c:v>SV1</c:v>
                </c:pt>
                <c:pt idx="1">
                  <c:v>SV2</c:v>
                </c:pt>
                <c:pt idx="2">
                  <c:v>SV3</c:v>
                </c:pt>
                <c:pt idx="3">
                  <c:v>SV4</c:v>
                </c:pt>
                <c:pt idx="4">
                  <c:v>SV5</c:v>
                </c:pt>
                <c:pt idx="5">
                  <c:v>SV6</c:v>
                </c:pt>
                <c:pt idx="6">
                  <c:v>SV7</c:v>
                </c:pt>
                <c:pt idx="7">
                  <c:v>SV9</c:v>
                </c:pt>
                <c:pt idx="8">
                  <c:v>SV10</c:v>
                </c:pt>
              </c:strCache>
            </c:strRef>
          </c:cat>
          <c:val>
            <c:numRef>
              <c:f>Phylogeny_Percentage!$H$5:$P$5</c:f>
              <c:numCache>
                <c:formatCode>General</c:formatCode>
                <c:ptCount val="9"/>
                <c:pt idx="0">
                  <c:v>4.5205402045544442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.307787876806382E-2</c:v>
                </c:pt>
                <c:pt idx="7">
                  <c:v>0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30D-4944-B837-0373D2FBAB57}"/>
            </c:ext>
          </c:extLst>
        </c:ser>
        <c:ser>
          <c:idx val="2"/>
          <c:order val="2"/>
          <c:tx>
            <c:strRef>
              <c:f>Phylogeny_Percentage!$C$6:$G$6</c:f>
              <c:strCache>
                <c:ptCount val="5"/>
                <c:pt idx="0">
                  <c:v>Euryarchaeota</c:v>
                </c:pt>
                <c:pt idx="1">
                  <c:v>Halobacteria</c:v>
                </c:pt>
                <c:pt idx="2">
                  <c:v>Halobacteriales</c:v>
                </c:pt>
                <c:pt idx="3">
                  <c:v>Halobacteriaceae</c:v>
                </c:pt>
                <c:pt idx="4">
                  <c:v>Halobacterium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Phylogeny_Percentage!$H$3:$P$3</c:f>
              <c:strCache>
                <c:ptCount val="9"/>
                <c:pt idx="0">
                  <c:v>SV1</c:v>
                </c:pt>
                <c:pt idx="1">
                  <c:v>SV2</c:v>
                </c:pt>
                <c:pt idx="2">
                  <c:v>SV3</c:v>
                </c:pt>
                <c:pt idx="3">
                  <c:v>SV4</c:v>
                </c:pt>
                <c:pt idx="4">
                  <c:v>SV5</c:v>
                </c:pt>
                <c:pt idx="5">
                  <c:v>SV6</c:v>
                </c:pt>
                <c:pt idx="6">
                  <c:v>SV7</c:v>
                </c:pt>
                <c:pt idx="7">
                  <c:v>SV9</c:v>
                </c:pt>
                <c:pt idx="8">
                  <c:v>SV10</c:v>
                </c:pt>
              </c:strCache>
            </c:strRef>
          </c:cat>
          <c:val>
            <c:numRef>
              <c:f>Phylogeny_Percentage!$H$6:$P$6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.382093595378279E-2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30D-4944-B837-0373D2FBAB57}"/>
            </c:ext>
          </c:extLst>
        </c:ser>
        <c:ser>
          <c:idx val="3"/>
          <c:order val="3"/>
          <c:tx>
            <c:strRef>
              <c:f>Phylogeny_Percentage!$C$7:$G$7</c:f>
              <c:strCache>
                <c:ptCount val="5"/>
                <c:pt idx="0">
                  <c:v>Euryarchaeota</c:v>
                </c:pt>
                <c:pt idx="1">
                  <c:v>Halobacteria</c:v>
                </c:pt>
                <c:pt idx="2">
                  <c:v>Halobacteriales</c:v>
                </c:pt>
                <c:pt idx="3">
                  <c:v>Halobacteriales_unclassified</c:v>
                </c:pt>
                <c:pt idx="4">
                  <c:v>Halobacteriales_unclassified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Phylogeny_Percentage!$H$3:$P$3</c:f>
              <c:strCache>
                <c:ptCount val="9"/>
                <c:pt idx="0">
                  <c:v>SV1</c:v>
                </c:pt>
                <c:pt idx="1">
                  <c:v>SV2</c:v>
                </c:pt>
                <c:pt idx="2">
                  <c:v>SV3</c:v>
                </c:pt>
                <c:pt idx="3">
                  <c:v>SV4</c:v>
                </c:pt>
                <c:pt idx="4">
                  <c:v>SV5</c:v>
                </c:pt>
                <c:pt idx="5">
                  <c:v>SV6</c:v>
                </c:pt>
                <c:pt idx="6">
                  <c:v>SV7</c:v>
                </c:pt>
                <c:pt idx="7">
                  <c:v>SV9</c:v>
                </c:pt>
                <c:pt idx="8">
                  <c:v>SV10</c:v>
                </c:pt>
              </c:strCache>
            </c:strRef>
          </c:cat>
          <c:val>
            <c:numRef>
              <c:f>Phylogeny_Percentage!$H$7:$P$7</c:f>
              <c:numCache>
                <c:formatCode>General</c:formatCode>
                <c:ptCount val="9"/>
                <c:pt idx="0">
                  <c:v>0</c:v>
                </c:pt>
                <c:pt idx="1">
                  <c:v>2.8301886792452828</c:v>
                </c:pt>
                <c:pt idx="2">
                  <c:v>0.41891083183722322</c:v>
                </c:pt>
                <c:pt idx="3">
                  <c:v>5.4234062797335874</c:v>
                </c:pt>
                <c:pt idx="4">
                  <c:v>0.53072394062525918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30D-4944-B837-0373D2FBAB57}"/>
            </c:ext>
          </c:extLst>
        </c:ser>
        <c:ser>
          <c:idx val="4"/>
          <c:order val="4"/>
          <c:tx>
            <c:strRef>
              <c:f>Phylogeny_Percentage!$C$8:$G$8</c:f>
              <c:strCache>
                <c:ptCount val="5"/>
                <c:pt idx="0">
                  <c:v>Euryarchaeota</c:v>
                </c:pt>
                <c:pt idx="1">
                  <c:v>Halobacteria</c:v>
                </c:pt>
                <c:pt idx="2">
                  <c:v>Halobacteriales</c:v>
                </c:pt>
                <c:pt idx="3">
                  <c:v>Halococcaceae</c:v>
                </c:pt>
                <c:pt idx="4">
                  <c:v>Halalkalicoccus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Phylogeny_Percentage!$H$3:$P$3</c:f>
              <c:strCache>
                <c:ptCount val="9"/>
                <c:pt idx="0">
                  <c:v>SV1</c:v>
                </c:pt>
                <c:pt idx="1">
                  <c:v>SV2</c:v>
                </c:pt>
                <c:pt idx="2">
                  <c:v>SV3</c:v>
                </c:pt>
                <c:pt idx="3">
                  <c:v>SV4</c:v>
                </c:pt>
                <c:pt idx="4">
                  <c:v>SV5</c:v>
                </c:pt>
                <c:pt idx="5">
                  <c:v>SV6</c:v>
                </c:pt>
                <c:pt idx="6">
                  <c:v>SV7</c:v>
                </c:pt>
                <c:pt idx="7">
                  <c:v>SV9</c:v>
                </c:pt>
                <c:pt idx="8">
                  <c:v>SV10</c:v>
                </c:pt>
              </c:strCache>
            </c:strRef>
          </c:cat>
          <c:val>
            <c:numRef>
              <c:f>Phylogeny_Percentage!$H$8:$P$8</c:f>
              <c:numCache>
                <c:formatCode>General</c:formatCode>
                <c:ptCount val="9"/>
                <c:pt idx="0">
                  <c:v>0</c:v>
                </c:pt>
                <c:pt idx="1">
                  <c:v>1.5094339622641511</c:v>
                </c:pt>
                <c:pt idx="2">
                  <c:v>0</c:v>
                </c:pt>
                <c:pt idx="3">
                  <c:v>4.5670789724072316</c:v>
                </c:pt>
                <c:pt idx="4">
                  <c:v>3.5934433479835257E-2</c:v>
                </c:pt>
                <c:pt idx="5">
                  <c:v>0.47189597315436244</c:v>
                </c:pt>
                <c:pt idx="6">
                  <c:v>1.307787876806382E-2</c:v>
                </c:pt>
                <c:pt idx="7">
                  <c:v>0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E30D-4944-B837-0373D2FBAB57}"/>
            </c:ext>
          </c:extLst>
        </c:ser>
        <c:ser>
          <c:idx val="5"/>
          <c:order val="5"/>
          <c:tx>
            <c:strRef>
              <c:f>Phylogeny_Percentage!$C$9:$G$9</c:f>
              <c:strCache>
                <c:ptCount val="5"/>
                <c:pt idx="0">
                  <c:v>Euryarchaeota</c:v>
                </c:pt>
                <c:pt idx="1">
                  <c:v>Halobacteria</c:v>
                </c:pt>
                <c:pt idx="2">
                  <c:v>Halobacteriales</c:v>
                </c:pt>
                <c:pt idx="3">
                  <c:v>Halococcaceae</c:v>
                </c:pt>
                <c:pt idx="4">
                  <c:v>Halococcaceae_unclassified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Phylogeny_Percentage!$H$3:$P$3</c:f>
              <c:strCache>
                <c:ptCount val="9"/>
                <c:pt idx="0">
                  <c:v>SV1</c:v>
                </c:pt>
                <c:pt idx="1">
                  <c:v>SV2</c:v>
                </c:pt>
                <c:pt idx="2">
                  <c:v>SV3</c:v>
                </c:pt>
                <c:pt idx="3">
                  <c:v>SV4</c:v>
                </c:pt>
                <c:pt idx="4">
                  <c:v>SV5</c:v>
                </c:pt>
                <c:pt idx="5">
                  <c:v>SV6</c:v>
                </c:pt>
                <c:pt idx="6">
                  <c:v>SV7</c:v>
                </c:pt>
                <c:pt idx="7">
                  <c:v>SV9</c:v>
                </c:pt>
                <c:pt idx="8">
                  <c:v>SV10</c:v>
                </c:pt>
              </c:strCache>
            </c:strRef>
          </c:cat>
          <c:val>
            <c:numRef>
              <c:f>Phylogeny_Percentage!$H$9:$P$9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9.5147478591817311E-2</c:v>
                </c:pt>
                <c:pt idx="4">
                  <c:v>3.3170246289078699E-2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E30D-4944-B837-0373D2FBAB57}"/>
            </c:ext>
          </c:extLst>
        </c:ser>
        <c:ser>
          <c:idx val="6"/>
          <c:order val="6"/>
          <c:tx>
            <c:strRef>
              <c:f>Phylogeny_Percentage!$C$10:$G$10</c:f>
              <c:strCache>
                <c:ptCount val="5"/>
                <c:pt idx="0">
                  <c:v>Euryarchaeota</c:v>
                </c:pt>
                <c:pt idx="1">
                  <c:v>Halobacteria</c:v>
                </c:pt>
                <c:pt idx="2">
                  <c:v>Halobacteriales</c:v>
                </c:pt>
                <c:pt idx="3">
                  <c:v>Halococcaceae</c:v>
                </c:pt>
                <c:pt idx="4">
                  <c:v>Halococcus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Phylogeny_Percentage!$H$3:$P$3</c:f>
              <c:strCache>
                <c:ptCount val="9"/>
                <c:pt idx="0">
                  <c:v>SV1</c:v>
                </c:pt>
                <c:pt idx="1">
                  <c:v>SV2</c:v>
                </c:pt>
                <c:pt idx="2">
                  <c:v>SV3</c:v>
                </c:pt>
                <c:pt idx="3">
                  <c:v>SV4</c:v>
                </c:pt>
                <c:pt idx="4">
                  <c:v>SV5</c:v>
                </c:pt>
                <c:pt idx="5">
                  <c:v>SV6</c:v>
                </c:pt>
                <c:pt idx="6">
                  <c:v>SV7</c:v>
                </c:pt>
                <c:pt idx="7">
                  <c:v>SV9</c:v>
                </c:pt>
                <c:pt idx="8">
                  <c:v>SV10</c:v>
                </c:pt>
              </c:strCache>
            </c:strRef>
          </c:cat>
          <c:val>
            <c:numRef>
              <c:f>Phylogeny_Percentage!$H$10:$P$10</c:f>
              <c:numCache>
                <c:formatCode>General</c:formatCode>
                <c:ptCount val="9"/>
                <c:pt idx="0">
                  <c:v>0</c:v>
                </c:pt>
                <c:pt idx="1">
                  <c:v>55.754716981132077</c:v>
                </c:pt>
                <c:pt idx="2">
                  <c:v>2.1543985637342908</c:v>
                </c:pt>
                <c:pt idx="3">
                  <c:v>52.235965746907709</c:v>
                </c:pt>
                <c:pt idx="4">
                  <c:v>99.386350443652049</c:v>
                </c:pt>
                <c:pt idx="5">
                  <c:v>0</c:v>
                </c:pt>
                <c:pt idx="6">
                  <c:v>0</c:v>
                </c:pt>
                <c:pt idx="7">
                  <c:v>8.2419846699085132E-3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E30D-4944-B837-0373D2FBAB57}"/>
            </c:ext>
          </c:extLst>
        </c:ser>
        <c:ser>
          <c:idx val="7"/>
          <c:order val="7"/>
          <c:tx>
            <c:strRef>
              <c:f>Phylogeny_Percentage!$C$11:$G$11</c:f>
              <c:strCache>
                <c:ptCount val="5"/>
                <c:pt idx="0">
                  <c:v>Euryarchaeota</c:v>
                </c:pt>
                <c:pt idx="1">
                  <c:v>Halobacteria</c:v>
                </c:pt>
                <c:pt idx="2">
                  <c:v>Halobacteriales</c:v>
                </c:pt>
                <c:pt idx="3">
                  <c:v>Haloferacaceae</c:v>
                </c:pt>
                <c:pt idx="4">
                  <c:v>Haloferacaceae_unclassified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Phylogeny_Percentage!$H$3:$P$3</c:f>
              <c:strCache>
                <c:ptCount val="9"/>
                <c:pt idx="0">
                  <c:v>SV1</c:v>
                </c:pt>
                <c:pt idx="1">
                  <c:v>SV2</c:v>
                </c:pt>
                <c:pt idx="2">
                  <c:v>SV3</c:v>
                </c:pt>
                <c:pt idx="3">
                  <c:v>SV4</c:v>
                </c:pt>
                <c:pt idx="4">
                  <c:v>SV5</c:v>
                </c:pt>
                <c:pt idx="5">
                  <c:v>SV6</c:v>
                </c:pt>
                <c:pt idx="6">
                  <c:v>SV7</c:v>
                </c:pt>
                <c:pt idx="7">
                  <c:v>SV9</c:v>
                </c:pt>
                <c:pt idx="8">
                  <c:v>SV10</c:v>
                </c:pt>
              </c:strCache>
            </c:strRef>
          </c:cat>
          <c:val>
            <c:numRef>
              <c:f>Phylogeny_Percentage!$H$11:$P$11</c:f>
              <c:numCache>
                <c:formatCode>General</c:formatCode>
                <c:ptCount val="9"/>
                <c:pt idx="0">
                  <c:v>0</c:v>
                </c:pt>
                <c:pt idx="1">
                  <c:v>0.18867924528301888</c:v>
                </c:pt>
                <c:pt idx="2">
                  <c:v>0</c:v>
                </c:pt>
                <c:pt idx="3">
                  <c:v>0.28544243577545197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E30D-4944-B837-0373D2FBAB57}"/>
            </c:ext>
          </c:extLst>
        </c:ser>
        <c:ser>
          <c:idx val="8"/>
          <c:order val="8"/>
          <c:tx>
            <c:strRef>
              <c:f>Phylogeny_Percentage!$C$12:$G$12</c:f>
              <c:strCache>
                <c:ptCount val="5"/>
                <c:pt idx="0">
                  <c:v>Euryarchaeota</c:v>
                </c:pt>
                <c:pt idx="1">
                  <c:v>Halobacteria</c:v>
                </c:pt>
                <c:pt idx="2">
                  <c:v>Halobacteriales</c:v>
                </c:pt>
                <c:pt idx="3">
                  <c:v>Haloferacaceae</c:v>
                </c:pt>
                <c:pt idx="4">
                  <c:v>uncultured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Phylogeny_Percentage!$H$3:$P$3</c:f>
              <c:strCache>
                <c:ptCount val="9"/>
                <c:pt idx="0">
                  <c:v>SV1</c:v>
                </c:pt>
                <c:pt idx="1">
                  <c:v>SV2</c:v>
                </c:pt>
                <c:pt idx="2">
                  <c:v>SV3</c:v>
                </c:pt>
                <c:pt idx="3">
                  <c:v>SV4</c:v>
                </c:pt>
                <c:pt idx="4">
                  <c:v>SV5</c:v>
                </c:pt>
                <c:pt idx="5">
                  <c:v>SV6</c:v>
                </c:pt>
                <c:pt idx="6">
                  <c:v>SV7</c:v>
                </c:pt>
                <c:pt idx="7">
                  <c:v>SV9</c:v>
                </c:pt>
                <c:pt idx="8">
                  <c:v>SV10</c:v>
                </c:pt>
              </c:strCache>
            </c:strRef>
          </c:cat>
          <c:val>
            <c:numRef>
              <c:f>Phylogeny_Percentage!$H$12:$P$12</c:f>
              <c:numCache>
                <c:formatCode>General</c:formatCode>
                <c:ptCount val="9"/>
                <c:pt idx="0">
                  <c:v>0</c:v>
                </c:pt>
                <c:pt idx="1">
                  <c:v>9.4339622641509441E-2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E30D-4944-B837-0373D2FBAB57}"/>
            </c:ext>
          </c:extLst>
        </c:ser>
        <c:ser>
          <c:idx val="9"/>
          <c:order val="9"/>
          <c:tx>
            <c:strRef>
              <c:f>Phylogeny_Percentage!$C$13:$G$13</c:f>
              <c:strCache>
                <c:ptCount val="5"/>
                <c:pt idx="0">
                  <c:v>Euryarchaeota</c:v>
                </c:pt>
                <c:pt idx="1">
                  <c:v>Halobacteria</c:v>
                </c:pt>
                <c:pt idx="2">
                  <c:v>Halobacteriales</c:v>
                </c:pt>
                <c:pt idx="3">
                  <c:v>uncultured</c:v>
                </c:pt>
                <c:pt idx="4">
                  <c:v>uncultured_ge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Phylogeny_Percentage!$H$3:$P$3</c:f>
              <c:strCache>
                <c:ptCount val="9"/>
                <c:pt idx="0">
                  <c:v>SV1</c:v>
                </c:pt>
                <c:pt idx="1">
                  <c:v>SV2</c:v>
                </c:pt>
                <c:pt idx="2">
                  <c:v>SV3</c:v>
                </c:pt>
                <c:pt idx="3">
                  <c:v>SV4</c:v>
                </c:pt>
                <c:pt idx="4">
                  <c:v>SV5</c:v>
                </c:pt>
                <c:pt idx="5">
                  <c:v>SV6</c:v>
                </c:pt>
                <c:pt idx="6">
                  <c:v>SV7</c:v>
                </c:pt>
                <c:pt idx="7">
                  <c:v>SV9</c:v>
                </c:pt>
                <c:pt idx="8">
                  <c:v>SV10</c:v>
                </c:pt>
              </c:strCache>
            </c:strRef>
          </c:cat>
          <c:val>
            <c:numRef>
              <c:f>Phylogeny_Percentage!$H$13:$P$13</c:f>
              <c:numCache>
                <c:formatCode>General</c:formatCode>
                <c:ptCount val="9"/>
                <c:pt idx="0">
                  <c:v>0</c:v>
                </c:pt>
                <c:pt idx="1">
                  <c:v>8.2075471698113205</c:v>
                </c:pt>
                <c:pt idx="2">
                  <c:v>0</c:v>
                </c:pt>
                <c:pt idx="3">
                  <c:v>12.940057088487155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E30D-4944-B837-0373D2FBAB57}"/>
            </c:ext>
          </c:extLst>
        </c:ser>
        <c:ser>
          <c:idx val="10"/>
          <c:order val="10"/>
          <c:tx>
            <c:strRef>
              <c:f>Phylogeny_Percentage!$C$14:$G$14</c:f>
              <c:strCache>
                <c:ptCount val="5"/>
                <c:pt idx="0">
                  <c:v>Euryarchaeota</c:v>
                </c:pt>
                <c:pt idx="1">
                  <c:v>Methanobacteria</c:v>
                </c:pt>
                <c:pt idx="2">
                  <c:v>Methanobacteriales</c:v>
                </c:pt>
                <c:pt idx="3">
                  <c:v>Methanobacteriaceae</c:v>
                </c:pt>
                <c:pt idx="4">
                  <c:v>Methanosphaera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Phylogeny_Percentage!$H$3:$P$3</c:f>
              <c:strCache>
                <c:ptCount val="9"/>
                <c:pt idx="0">
                  <c:v>SV1</c:v>
                </c:pt>
                <c:pt idx="1">
                  <c:v>SV2</c:v>
                </c:pt>
                <c:pt idx="2">
                  <c:v>SV3</c:v>
                </c:pt>
                <c:pt idx="3">
                  <c:v>SV4</c:v>
                </c:pt>
                <c:pt idx="4">
                  <c:v>SV5</c:v>
                </c:pt>
                <c:pt idx="5">
                  <c:v>SV6</c:v>
                </c:pt>
                <c:pt idx="6">
                  <c:v>SV7</c:v>
                </c:pt>
                <c:pt idx="7">
                  <c:v>SV9</c:v>
                </c:pt>
                <c:pt idx="8">
                  <c:v>SV10</c:v>
                </c:pt>
              </c:strCache>
            </c:strRef>
          </c:cat>
          <c:val>
            <c:numRef>
              <c:f>Phylogeny_Percentage!$H$14:$P$14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.961681815209573E-2</c:v>
                </c:pt>
                <c:pt idx="7">
                  <c:v>0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E30D-4944-B837-0373D2FBAB57}"/>
            </c:ext>
          </c:extLst>
        </c:ser>
        <c:ser>
          <c:idx val="11"/>
          <c:order val="11"/>
          <c:tx>
            <c:strRef>
              <c:f>Phylogeny_Percentage!$C$15:$G$15</c:f>
              <c:strCache>
                <c:ptCount val="5"/>
                <c:pt idx="0">
                  <c:v>Euryarchaeota</c:v>
                </c:pt>
                <c:pt idx="1">
                  <c:v>Thermoplasmata</c:v>
                </c:pt>
                <c:pt idx="2">
                  <c:v>Thermoplasmata_unclassified</c:v>
                </c:pt>
                <c:pt idx="3">
                  <c:v>Thermoplasmata_unclassified</c:v>
                </c:pt>
                <c:pt idx="4">
                  <c:v>Thermoplasmata_unclassified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Phylogeny_Percentage!$H$3:$P$3</c:f>
              <c:strCache>
                <c:ptCount val="9"/>
                <c:pt idx="0">
                  <c:v>SV1</c:v>
                </c:pt>
                <c:pt idx="1">
                  <c:v>SV2</c:v>
                </c:pt>
                <c:pt idx="2">
                  <c:v>SV3</c:v>
                </c:pt>
                <c:pt idx="3">
                  <c:v>SV4</c:v>
                </c:pt>
                <c:pt idx="4">
                  <c:v>SV5</c:v>
                </c:pt>
                <c:pt idx="5">
                  <c:v>SV6</c:v>
                </c:pt>
                <c:pt idx="6">
                  <c:v>SV7</c:v>
                </c:pt>
                <c:pt idx="7">
                  <c:v>SV9</c:v>
                </c:pt>
                <c:pt idx="8">
                  <c:v>SV10</c:v>
                </c:pt>
              </c:strCache>
            </c:strRef>
          </c:cat>
          <c:val>
            <c:numRef>
              <c:f>Phylogeny_Percentage!$H$15:$P$15</c:f>
              <c:numCache>
                <c:formatCode>General</c:formatCode>
                <c:ptCount val="9"/>
                <c:pt idx="0">
                  <c:v>0.61027292761484997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2.4782580265480938</c:v>
                </c:pt>
                <c:pt idx="7">
                  <c:v>0</c:v>
                </c:pt>
                <c:pt idx="8">
                  <c:v>1.90217391304347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E30D-4944-B837-0373D2FBAB57}"/>
            </c:ext>
          </c:extLst>
        </c:ser>
        <c:ser>
          <c:idx val="12"/>
          <c:order val="12"/>
          <c:tx>
            <c:strRef>
              <c:f>Phylogeny_Percentage!$C$16:$G$16</c:f>
              <c:strCache>
                <c:ptCount val="5"/>
                <c:pt idx="0">
                  <c:v>Euryarchaeota</c:v>
                </c:pt>
                <c:pt idx="1">
                  <c:v>Thermoplasmata</c:v>
                </c:pt>
                <c:pt idx="2">
                  <c:v>uncultured</c:v>
                </c:pt>
                <c:pt idx="3">
                  <c:v>uncultured_fa</c:v>
                </c:pt>
                <c:pt idx="4">
                  <c:v>uncultured_ge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Phylogeny_Percentage!$H$3:$P$3</c:f>
              <c:strCache>
                <c:ptCount val="9"/>
                <c:pt idx="0">
                  <c:v>SV1</c:v>
                </c:pt>
                <c:pt idx="1">
                  <c:v>SV2</c:v>
                </c:pt>
                <c:pt idx="2">
                  <c:v>SV3</c:v>
                </c:pt>
                <c:pt idx="3">
                  <c:v>SV4</c:v>
                </c:pt>
                <c:pt idx="4">
                  <c:v>SV5</c:v>
                </c:pt>
                <c:pt idx="5">
                  <c:v>SV6</c:v>
                </c:pt>
                <c:pt idx="6">
                  <c:v>SV7</c:v>
                </c:pt>
                <c:pt idx="7">
                  <c:v>SV9</c:v>
                </c:pt>
                <c:pt idx="8">
                  <c:v>SV10</c:v>
                </c:pt>
              </c:strCache>
            </c:strRef>
          </c:cat>
          <c:val>
            <c:numRef>
              <c:f>Phylogeny_Percentage!$H$16:$P$16</c:f>
              <c:numCache>
                <c:formatCode>General</c:formatCode>
                <c:ptCount val="9"/>
                <c:pt idx="0">
                  <c:v>0.15821890715940554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5.1984568103053688</c:v>
                </c:pt>
                <c:pt idx="7">
                  <c:v>0</c:v>
                </c:pt>
                <c:pt idx="8">
                  <c:v>1.35869565217391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E30D-4944-B837-0373D2FBAB57}"/>
            </c:ext>
          </c:extLst>
        </c:ser>
        <c:ser>
          <c:idx val="13"/>
          <c:order val="13"/>
          <c:tx>
            <c:strRef>
              <c:f>Phylogeny_Percentage!$C$17:$G$17</c:f>
              <c:strCache>
                <c:ptCount val="5"/>
                <c:pt idx="0">
                  <c:v>Nanoarchaeaeota</c:v>
                </c:pt>
                <c:pt idx="1">
                  <c:v>Nanoarchaeaeota_unclassified</c:v>
                </c:pt>
                <c:pt idx="2">
                  <c:v>Nanoarchaeaeota_unclassified</c:v>
                </c:pt>
                <c:pt idx="3">
                  <c:v>Nanoarchaeaeota_unclassified</c:v>
                </c:pt>
                <c:pt idx="4">
                  <c:v>Nanoarchaeaeota_unclassified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Phylogeny_Percentage!$H$3:$P$3</c:f>
              <c:strCache>
                <c:ptCount val="9"/>
                <c:pt idx="0">
                  <c:v>SV1</c:v>
                </c:pt>
                <c:pt idx="1">
                  <c:v>SV2</c:v>
                </c:pt>
                <c:pt idx="2">
                  <c:v>SV3</c:v>
                </c:pt>
                <c:pt idx="3">
                  <c:v>SV4</c:v>
                </c:pt>
                <c:pt idx="4">
                  <c:v>SV5</c:v>
                </c:pt>
                <c:pt idx="5">
                  <c:v>SV6</c:v>
                </c:pt>
                <c:pt idx="6">
                  <c:v>SV7</c:v>
                </c:pt>
                <c:pt idx="7">
                  <c:v>SV9</c:v>
                </c:pt>
                <c:pt idx="8">
                  <c:v>SV10</c:v>
                </c:pt>
              </c:strCache>
            </c:strRef>
          </c:cat>
          <c:val>
            <c:numRef>
              <c:f>Phylogeny_Percentage!$H$17:$P$17</c:f>
              <c:numCache>
                <c:formatCode>General</c:formatCode>
                <c:ptCount val="9"/>
                <c:pt idx="0">
                  <c:v>2.2602701022772221E-2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2.0973154362416108E-2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E30D-4944-B837-0373D2FBAB57}"/>
            </c:ext>
          </c:extLst>
        </c:ser>
        <c:ser>
          <c:idx val="14"/>
          <c:order val="14"/>
          <c:tx>
            <c:strRef>
              <c:f>Phylogeny_Percentage!$C$18:$G$18</c:f>
              <c:strCache>
                <c:ptCount val="5"/>
                <c:pt idx="0">
                  <c:v>Nanoarchaeaeota</c:v>
                </c:pt>
                <c:pt idx="1">
                  <c:v>Woesearchaeia</c:v>
                </c:pt>
                <c:pt idx="2">
                  <c:v>Woesearchaeia_or</c:v>
                </c:pt>
                <c:pt idx="3">
                  <c:v>Woesearchaeia_fa</c:v>
                </c:pt>
                <c:pt idx="4">
                  <c:v>Woesearchaeia_ge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Phylogeny_Percentage!$H$3:$P$3</c:f>
              <c:strCache>
                <c:ptCount val="9"/>
                <c:pt idx="0">
                  <c:v>SV1</c:v>
                </c:pt>
                <c:pt idx="1">
                  <c:v>SV2</c:v>
                </c:pt>
                <c:pt idx="2">
                  <c:v>SV3</c:v>
                </c:pt>
                <c:pt idx="3">
                  <c:v>SV4</c:v>
                </c:pt>
                <c:pt idx="4">
                  <c:v>SV5</c:v>
                </c:pt>
                <c:pt idx="5">
                  <c:v>SV6</c:v>
                </c:pt>
                <c:pt idx="6">
                  <c:v>SV7</c:v>
                </c:pt>
                <c:pt idx="7">
                  <c:v>SV9</c:v>
                </c:pt>
                <c:pt idx="8">
                  <c:v>SV10</c:v>
                </c:pt>
              </c:strCache>
            </c:strRef>
          </c:cat>
          <c:val>
            <c:numRef>
              <c:f>Phylogeny_Percentage!$H$18:$P$18</c:f>
              <c:numCache>
                <c:formatCode>General</c:formatCode>
                <c:ptCount val="9"/>
                <c:pt idx="0">
                  <c:v>2.0342430920495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2.936241610738255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E30D-4944-B837-0373D2FBAB57}"/>
            </c:ext>
          </c:extLst>
        </c:ser>
        <c:ser>
          <c:idx val="15"/>
          <c:order val="15"/>
          <c:tx>
            <c:strRef>
              <c:f>Phylogeny_Percentage!$C$19:$G$19</c:f>
              <c:strCache>
                <c:ptCount val="5"/>
                <c:pt idx="0">
                  <c:v>Thaumarchaeota</c:v>
                </c:pt>
                <c:pt idx="1">
                  <c:v>Nitrososphaeria</c:v>
                </c:pt>
                <c:pt idx="2">
                  <c:v>Nitrosopumilales</c:v>
                </c:pt>
                <c:pt idx="3">
                  <c:v>Nitrosopumilaceae</c:v>
                </c:pt>
                <c:pt idx="4">
                  <c:v>Candidatus_Nitrosoarchaeum</c:v>
                </c:pt>
              </c:strCache>
            </c:strRef>
          </c:tx>
          <c:spPr>
            <a:solidFill>
              <a:schemeClr val="accent4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Phylogeny_Percentage!$H$3:$P$3</c:f>
              <c:strCache>
                <c:ptCount val="9"/>
                <c:pt idx="0">
                  <c:v>SV1</c:v>
                </c:pt>
                <c:pt idx="1">
                  <c:v>SV2</c:v>
                </c:pt>
                <c:pt idx="2">
                  <c:v>SV3</c:v>
                </c:pt>
                <c:pt idx="3">
                  <c:v>SV4</c:v>
                </c:pt>
                <c:pt idx="4">
                  <c:v>SV5</c:v>
                </c:pt>
                <c:pt idx="5">
                  <c:v>SV6</c:v>
                </c:pt>
                <c:pt idx="6">
                  <c:v>SV7</c:v>
                </c:pt>
                <c:pt idx="7">
                  <c:v>SV9</c:v>
                </c:pt>
                <c:pt idx="8">
                  <c:v>SV10</c:v>
                </c:pt>
              </c:strCache>
            </c:strRef>
          </c:cat>
          <c:val>
            <c:numRef>
              <c:f>Phylogeny_Percentage!$H$19:$P$19</c:f>
              <c:numCache>
                <c:formatCode>General</c:formatCode>
                <c:ptCount val="9"/>
                <c:pt idx="0">
                  <c:v>0.30513646380742498</c:v>
                </c:pt>
                <c:pt idx="1">
                  <c:v>0</c:v>
                </c:pt>
                <c:pt idx="2">
                  <c:v>0</c:v>
                </c:pt>
                <c:pt idx="3">
                  <c:v>0.19029495718363462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E30D-4944-B837-0373D2FBAB57}"/>
            </c:ext>
          </c:extLst>
        </c:ser>
        <c:ser>
          <c:idx val="16"/>
          <c:order val="16"/>
          <c:tx>
            <c:strRef>
              <c:f>Phylogeny_Percentage!$C$20:$G$20</c:f>
              <c:strCache>
                <c:ptCount val="5"/>
                <c:pt idx="0">
                  <c:v>Thaumarchaeota</c:v>
                </c:pt>
                <c:pt idx="1">
                  <c:v>Nitrososphaeria</c:v>
                </c:pt>
                <c:pt idx="2">
                  <c:v>Nitrosopumilales</c:v>
                </c:pt>
                <c:pt idx="3">
                  <c:v>Nitrosopumilaceae</c:v>
                </c:pt>
                <c:pt idx="4">
                  <c:v>Candidatus_Nitrosotenuis</c:v>
                </c:pt>
              </c:strCache>
            </c:strRef>
          </c:tx>
          <c:spPr>
            <a:solidFill>
              <a:schemeClr val="accent5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Phylogeny_Percentage!$H$3:$P$3</c:f>
              <c:strCache>
                <c:ptCount val="9"/>
                <c:pt idx="0">
                  <c:v>SV1</c:v>
                </c:pt>
                <c:pt idx="1">
                  <c:v>SV2</c:v>
                </c:pt>
                <c:pt idx="2">
                  <c:v>SV3</c:v>
                </c:pt>
                <c:pt idx="3">
                  <c:v>SV4</c:v>
                </c:pt>
                <c:pt idx="4">
                  <c:v>SV5</c:v>
                </c:pt>
                <c:pt idx="5">
                  <c:v>SV6</c:v>
                </c:pt>
                <c:pt idx="6">
                  <c:v>SV7</c:v>
                </c:pt>
                <c:pt idx="7">
                  <c:v>SV9</c:v>
                </c:pt>
                <c:pt idx="8">
                  <c:v>SV10</c:v>
                </c:pt>
              </c:strCache>
            </c:strRef>
          </c:cat>
          <c:val>
            <c:numRef>
              <c:f>Phylogeny_Percentage!$H$20:$P$20</c:f>
              <c:numCache>
                <c:formatCode>General</c:formatCode>
                <c:ptCount val="9"/>
                <c:pt idx="0">
                  <c:v>64.649375600384246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33557046979865773</c:v>
                </c:pt>
                <c:pt idx="6">
                  <c:v>70.365526711567384</c:v>
                </c:pt>
                <c:pt idx="7">
                  <c:v>0</c:v>
                </c:pt>
                <c:pt idx="8">
                  <c:v>28.5326086956521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E30D-4944-B837-0373D2FBAB57}"/>
            </c:ext>
          </c:extLst>
        </c:ser>
        <c:ser>
          <c:idx val="17"/>
          <c:order val="17"/>
          <c:tx>
            <c:strRef>
              <c:f>Phylogeny_Percentage!$C$21:$G$21</c:f>
              <c:strCache>
                <c:ptCount val="5"/>
                <c:pt idx="0">
                  <c:v>Thaumarchaeota</c:v>
                </c:pt>
                <c:pt idx="1">
                  <c:v>Nitrososphaeria</c:v>
                </c:pt>
                <c:pt idx="2">
                  <c:v>Nitrosopumilales</c:v>
                </c:pt>
                <c:pt idx="3">
                  <c:v>Nitrosopumilaceae</c:v>
                </c:pt>
                <c:pt idx="4">
                  <c:v>Nitrosopumilaceae_ge</c:v>
                </c:pt>
              </c:strCache>
            </c:strRef>
          </c:tx>
          <c:spPr>
            <a:solidFill>
              <a:schemeClr val="accent6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Phylogeny_Percentage!$H$3:$P$3</c:f>
              <c:strCache>
                <c:ptCount val="9"/>
                <c:pt idx="0">
                  <c:v>SV1</c:v>
                </c:pt>
                <c:pt idx="1">
                  <c:v>SV2</c:v>
                </c:pt>
                <c:pt idx="2">
                  <c:v>SV3</c:v>
                </c:pt>
                <c:pt idx="3">
                  <c:v>SV4</c:v>
                </c:pt>
                <c:pt idx="4">
                  <c:v>SV5</c:v>
                </c:pt>
                <c:pt idx="5">
                  <c:v>SV6</c:v>
                </c:pt>
                <c:pt idx="6">
                  <c:v>SV7</c:v>
                </c:pt>
                <c:pt idx="7">
                  <c:v>SV9</c:v>
                </c:pt>
                <c:pt idx="8">
                  <c:v>SV10</c:v>
                </c:pt>
              </c:strCache>
            </c:strRef>
          </c:cat>
          <c:val>
            <c:numRef>
              <c:f>Phylogeny_Percentage!$H$21:$P$21</c:f>
              <c:numCache>
                <c:formatCode>General</c:formatCode>
                <c:ptCount val="9"/>
                <c:pt idx="0">
                  <c:v>10.13731140871334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E30D-4944-B837-0373D2FBAB57}"/>
            </c:ext>
          </c:extLst>
        </c:ser>
        <c:ser>
          <c:idx val="18"/>
          <c:order val="18"/>
          <c:tx>
            <c:strRef>
              <c:f>Phylogeny_Percentage!$C$22:$G$22</c:f>
              <c:strCache>
                <c:ptCount val="5"/>
                <c:pt idx="0">
                  <c:v>Thaumarchaeota</c:v>
                </c:pt>
                <c:pt idx="1">
                  <c:v>Nitrososphaeria</c:v>
                </c:pt>
                <c:pt idx="2">
                  <c:v>Nitrosopumilales</c:v>
                </c:pt>
                <c:pt idx="3">
                  <c:v>Nitrosopumilaceae</c:v>
                </c:pt>
                <c:pt idx="4">
                  <c:v>Nitrosopumilaceae_unclassified</c:v>
                </c:pt>
              </c:strCache>
            </c:strRef>
          </c:tx>
          <c:spPr>
            <a:solidFill>
              <a:schemeClr val="accent1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Phylogeny_Percentage!$H$3:$P$3</c:f>
              <c:strCache>
                <c:ptCount val="9"/>
                <c:pt idx="0">
                  <c:v>SV1</c:v>
                </c:pt>
                <c:pt idx="1">
                  <c:v>SV2</c:v>
                </c:pt>
                <c:pt idx="2">
                  <c:v>SV3</c:v>
                </c:pt>
                <c:pt idx="3">
                  <c:v>SV4</c:v>
                </c:pt>
                <c:pt idx="4">
                  <c:v>SV5</c:v>
                </c:pt>
                <c:pt idx="5">
                  <c:v>SV6</c:v>
                </c:pt>
                <c:pt idx="6">
                  <c:v>SV7</c:v>
                </c:pt>
                <c:pt idx="7">
                  <c:v>SV9</c:v>
                </c:pt>
                <c:pt idx="8">
                  <c:v>SV10</c:v>
                </c:pt>
              </c:strCache>
            </c:strRef>
          </c:cat>
          <c:val>
            <c:numRef>
              <c:f>Phylogeny_Percentage!$H$22:$P$22</c:f>
              <c:numCache>
                <c:formatCode>General</c:formatCode>
                <c:ptCount val="9"/>
                <c:pt idx="0">
                  <c:v>0.22037633497202916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E30D-4944-B837-0373D2FBAB57}"/>
            </c:ext>
          </c:extLst>
        </c:ser>
        <c:ser>
          <c:idx val="19"/>
          <c:order val="19"/>
          <c:tx>
            <c:strRef>
              <c:f>Phylogeny_Percentage!$C$23:$G$23</c:f>
              <c:strCache>
                <c:ptCount val="5"/>
                <c:pt idx="0">
                  <c:v>Thaumarchaeota</c:v>
                </c:pt>
                <c:pt idx="1">
                  <c:v>Nitrososphaeria</c:v>
                </c:pt>
                <c:pt idx="2">
                  <c:v>Nitrososphaerales</c:v>
                </c:pt>
                <c:pt idx="3">
                  <c:v>Nitrososphaeraceae</c:v>
                </c:pt>
                <c:pt idx="4">
                  <c:v>Candidatus_Nitrocosmicus</c:v>
                </c:pt>
              </c:strCache>
            </c:strRef>
          </c:tx>
          <c:spPr>
            <a:solidFill>
              <a:schemeClr val="accent2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Phylogeny_Percentage!$H$3:$P$3</c:f>
              <c:strCache>
                <c:ptCount val="9"/>
                <c:pt idx="0">
                  <c:v>SV1</c:v>
                </c:pt>
                <c:pt idx="1">
                  <c:v>SV2</c:v>
                </c:pt>
                <c:pt idx="2">
                  <c:v>SV3</c:v>
                </c:pt>
                <c:pt idx="3">
                  <c:v>SV4</c:v>
                </c:pt>
                <c:pt idx="4">
                  <c:v>SV5</c:v>
                </c:pt>
                <c:pt idx="5">
                  <c:v>SV6</c:v>
                </c:pt>
                <c:pt idx="6">
                  <c:v>SV7</c:v>
                </c:pt>
                <c:pt idx="7">
                  <c:v>SV9</c:v>
                </c:pt>
                <c:pt idx="8">
                  <c:v>SV10</c:v>
                </c:pt>
              </c:strCache>
            </c:strRef>
          </c:cat>
          <c:val>
            <c:numRef>
              <c:f>Phylogeny_Percentage!$H$23:$P$23</c:f>
              <c:numCache>
                <c:formatCode>General</c:formatCode>
                <c:ptCount val="9"/>
                <c:pt idx="0">
                  <c:v>11.459569418545517</c:v>
                </c:pt>
                <c:pt idx="1">
                  <c:v>31.320754716981131</c:v>
                </c:pt>
                <c:pt idx="2">
                  <c:v>92.28007181328546</c:v>
                </c:pt>
                <c:pt idx="3">
                  <c:v>24.262607040913416</c:v>
                </c:pt>
                <c:pt idx="4">
                  <c:v>0</c:v>
                </c:pt>
                <c:pt idx="5">
                  <c:v>94.68330536912751</c:v>
                </c:pt>
                <c:pt idx="6">
                  <c:v>20.904989210750017</c:v>
                </c:pt>
                <c:pt idx="7">
                  <c:v>99.728014505893015</c:v>
                </c:pt>
                <c:pt idx="8">
                  <c:v>60.8695652173913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3-E30D-4944-B837-0373D2FBAB57}"/>
            </c:ext>
          </c:extLst>
        </c:ser>
        <c:ser>
          <c:idx val="20"/>
          <c:order val="20"/>
          <c:tx>
            <c:strRef>
              <c:f>Phylogeny_Percentage!$C$24:$G$24</c:f>
              <c:strCache>
                <c:ptCount val="5"/>
                <c:pt idx="0">
                  <c:v>Thaumarchaeota</c:v>
                </c:pt>
                <c:pt idx="1">
                  <c:v>Nitrososphaeria</c:v>
                </c:pt>
                <c:pt idx="2">
                  <c:v>Nitrososphaerales</c:v>
                </c:pt>
                <c:pt idx="3">
                  <c:v>Nitrososphaeraceae</c:v>
                </c:pt>
                <c:pt idx="4">
                  <c:v>Candidatus_Nitrososphaera</c:v>
                </c:pt>
              </c:strCache>
            </c:strRef>
          </c:tx>
          <c:spPr>
            <a:solidFill>
              <a:schemeClr val="accent3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Phylogeny_Percentage!$H$3:$P$3</c:f>
              <c:strCache>
                <c:ptCount val="9"/>
                <c:pt idx="0">
                  <c:v>SV1</c:v>
                </c:pt>
                <c:pt idx="1">
                  <c:v>SV2</c:v>
                </c:pt>
                <c:pt idx="2">
                  <c:v>SV3</c:v>
                </c:pt>
                <c:pt idx="3">
                  <c:v>SV4</c:v>
                </c:pt>
                <c:pt idx="4">
                  <c:v>SV5</c:v>
                </c:pt>
                <c:pt idx="5">
                  <c:v>SV6</c:v>
                </c:pt>
                <c:pt idx="6">
                  <c:v>SV7</c:v>
                </c:pt>
                <c:pt idx="7">
                  <c:v>SV9</c:v>
                </c:pt>
                <c:pt idx="8">
                  <c:v>SV10</c:v>
                </c:pt>
              </c:strCache>
            </c:strRef>
          </c:cat>
          <c:val>
            <c:numRef>
              <c:f>Phylogeny_Percentage!$H$24:$P$24</c:f>
              <c:numCache>
                <c:formatCode>General</c:formatCode>
                <c:ptCount val="9"/>
                <c:pt idx="0">
                  <c:v>9.4253263264960161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91233221476510062</c:v>
                </c:pt>
                <c:pt idx="6">
                  <c:v>6.5389393840319101E-3</c:v>
                </c:pt>
                <c:pt idx="7">
                  <c:v>0</c:v>
                </c:pt>
                <c:pt idx="8">
                  <c:v>7.33695652173913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E30D-4944-B837-0373D2FBAB57}"/>
            </c:ext>
          </c:extLst>
        </c:ser>
        <c:ser>
          <c:idx val="21"/>
          <c:order val="21"/>
          <c:tx>
            <c:strRef>
              <c:f>Phylogeny_Percentage!$C$25:$G$25</c:f>
              <c:strCache>
                <c:ptCount val="5"/>
                <c:pt idx="0">
                  <c:v>Thaumarchaeota</c:v>
                </c:pt>
                <c:pt idx="1">
                  <c:v>Nitrososphaeria</c:v>
                </c:pt>
                <c:pt idx="2">
                  <c:v>Nitrososphaerales</c:v>
                </c:pt>
                <c:pt idx="3">
                  <c:v>Nitrososphaeraceae</c:v>
                </c:pt>
                <c:pt idx="4">
                  <c:v>Nitrososphaeraceae_ge</c:v>
                </c:pt>
              </c:strCache>
            </c:strRef>
          </c:tx>
          <c:spPr>
            <a:solidFill>
              <a:schemeClr val="accent4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Phylogeny_Percentage!$H$3:$P$3</c:f>
              <c:strCache>
                <c:ptCount val="9"/>
                <c:pt idx="0">
                  <c:v>SV1</c:v>
                </c:pt>
                <c:pt idx="1">
                  <c:v>SV2</c:v>
                </c:pt>
                <c:pt idx="2">
                  <c:v>SV3</c:v>
                </c:pt>
                <c:pt idx="3">
                  <c:v>SV4</c:v>
                </c:pt>
                <c:pt idx="4">
                  <c:v>SV5</c:v>
                </c:pt>
                <c:pt idx="5">
                  <c:v>SV6</c:v>
                </c:pt>
                <c:pt idx="6">
                  <c:v>SV7</c:v>
                </c:pt>
                <c:pt idx="7">
                  <c:v>SV9</c:v>
                </c:pt>
                <c:pt idx="8">
                  <c:v>SV10</c:v>
                </c:pt>
              </c:strCache>
            </c:strRef>
          </c:cat>
          <c:val>
            <c:numRef>
              <c:f>Phylogeny_Percentage!$H$25:$P$25</c:f>
              <c:numCache>
                <c:formatCode>General</c:formatCode>
                <c:ptCount val="9"/>
                <c:pt idx="0">
                  <c:v>0.51421144826806808</c:v>
                </c:pt>
                <c:pt idx="1">
                  <c:v>0</c:v>
                </c:pt>
                <c:pt idx="2">
                  <c:v>4.6678635547576306</c:v>
                </c:pt>
                <c:pt idx="3">
                  <c:v>0</c:v>
                </c:pt>
                <c:pt idx="4">
                  <c:v>0</c:v>
                </c:pt>
                <c:pt idx="5">
                  <c:v>4.1946308724832217E-2</c:v>
                </c:pt>
                <c:pt idx="6">
                  <c:v>0.9481462106846269</c:v>
                </c:pt>
                <c:pt idx="7">
                  <c:v>0.18956564740789583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5-E30D-4944-B837-0373D2FBAB57}"/>
            </c:ext>
          </c:extLst>
        </c:ser>
        <c:ser>
          <c:idx val="22"/>
          <c:order val="22"/>
          <c:tx>
            <c:strRef>
              <c:f>Phylogeny_Percentage!$C$26:$G$26</c:f>
              <c:strCache>
                <c:ptCount val="5"/>
                <c:pt idx="0">
                  <c:v>Thaumarchaeota</c:v>
                </c:pt>
                <c:pt idx="1">
                  <c:v>Nitrososphaeria</c:v>
                </c:pt>
                <c:pt idx="2">
                  <c:v>Nitrososphaerales</c:v>
                </c:pt>
                <c:pt idx="3">
                  <c:v>Nitrososphaeraceae</c:v>
                </c:pt>
                <c:pt idx="4">
                  <c:v>Nitrososphaeraceae_unclassified</c:v>
                </c:pt>
              </c:strCache>
            </c:strRef>
          </c:tx>
          <c:spPr>
            <a:solidFill>
              <a:schemeClr val="accent5">
                <a:lumMod val="80000"/>
              </a:schemeClr>
            </a:solidFill>
            <a:ln>
              <a:noFill/>
            </a:ln>
            <a:effectLst/>
          </c:spPr>
          <c:invertIfNegative val="0"/>
          <c:cat>
            <c:strRef>
              <c:f>Phylogeny_Percentage!$H$3:$P$3</c:f>
              <c:strCache>
                <c:ptCount val="9"/>
                <c:pt idx="0">
                  <c:v>SV1</c:v>
                </c:pt>
                <c:pt idx="1">
                  <c:v>SV2</c:v>
                </c:pt>
                <c:pt idx="2">
                  <c:v>SV3</c:v>
                </c:pt>
                <c:pt idx="3">
                  <c:v>SV4</c:v>
                </c:pt>
                <c:pt idx="4">
                  <c:v>SV5</c:v>
                </c:pt>
                <c:pt idx="5">
                  <c:v>SV6</c:v>
                </c:pt>
                <c:pt idx="6">
                  <c:v>SV7</c:v>
                </c:pt>
                <c:pt idx="7">
                  <c:v>SV9</c:v>
                </c:pt>
                <c:pt idx="8">
                  <c:v>SV10</c:v>
                </c:pt>
              </c:strCache>
            </c:strRef>
          </c:cat>
          <c:val>
            <c:numRef>
              <c:f>Phylogeny_Percentage!$H$26:$P$26</c:f>
              <c:numCache>
                <c:formatCode>General</c:formatCode>
                <c:ptCount val="9"/>
                <c:pt idx="0">
                  <c:v>0.38424591738712777</c:v>
                </c:pt>
                <c:pt idx="1">
                  <c:v>9.4339622641509441E-2</c:v>
                </c:pt>
                <c:pt idx="2">
                  <c:v>0.47875523638539796</c:v>
                </c:pt>
                <c:pt idx="3">
                  <c:v>0</c:v>
                </c:pt>
                <c:pt idx="4">
                  <c:v>0</c:v>
                </c:pt>
                <c:pt idx="5">
                  <c:v>0.59773489932885904</c:v>
                </c:pt>
                <c:pt idx="6">
                  <c:v>5.2311515072255281E-2</c:v>
                </c:pt>
                <c:pt idx="7">
                  <c:v>7.4177862029176631E-2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E30D-4944-B837-0373D2FBAB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648761424"/>
        <c:axId val="650833168"/>
      </c:barChart>
      <c:catAx>
        <c:axId val="64876142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50833168"/>
        <c:crosses val="autoZero"/>
        <c:auto val="1"/>
        <c:lblAlgn val="ctr"/>
        <c:lblOffset val="100"/>
        <c:noMultiLvlLbl val="0"/>
      </c:catAx>
      <c:valAx>
        <c:axId val="65083316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487614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1053328281657"/>
          <c:y val="0.48732214215592423"/>
          <c:w val="0.66914130702447061"/>
          <c:h val="0.4884349852308065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502F89-EE0C-41DF-A532-E86202D7C2E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pt-PT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91C7BEF-F8F7-4351-8196-4FF1B335B60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pt-P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5DE932-220E-453A-BF02-64BFC8ED0B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A9F78-BE60-46E7-BF98-1960E6ABC729}" type="datetimeFigureOut">
              <a:rPr lang="pt-PT" smtClean="0"/>
              <a:t>22/02/2021</a:t>
            </a:fld>
            <a:endParaRPr lang="pt-P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3C9BD4-4B48-4098-80E9-3A73A6E2E1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469DE8-87A3-494D-BCFA-D600BFF0D2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2C8B4-FAB2-4C26-9897-DCAAC3225491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427418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A3612B-F737-4DB0-AFDB-85E42EEC00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pt-P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8BACC4E-C58E-4339-A69E-9748D78C97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t-P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6D2CF7-55A1-469D-99A0-21C9068F03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A9F78-BE60-46E7-BF98-1960E6ABC729}" type="datetimeFigureOut">
              <a:rPr lang="pt-PT" smtClean="0"/>
              <a:t>22/02/2021</a:t>
            </a:fld>
            <a:endParaRPr lang="pt-P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E53599-0C31-4B52-B814-8E067AED6F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3F97D3-E554-4E2A-BE3A-320A37DD7D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2C8B4-FAB2-4C26-9897-DCAAC3225491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2687873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E87810C-3974-46D4-B501-6B26E1CC847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pt-P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068995B-B6AB-41A1-A945-2EA58E020E6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t-P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7E8BA2-80F9-4B59-A0D2-7C2231CB40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A9F78-BE60-46E7-BF98-1960E6ABC729}" type="datetimeFigureOut">
              <a:rPr lang="pt-PT" smtClean="0"/>
              <a:t>22/02/2021</a:t>
            </a:fld>
            <a:endParaRPr lang="pt-P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3B632E-1841-48B3-806D-CCD9E452DF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33487B-0A3F-4DC5-8CBD-938C7158F3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2C8B4-FAB2-4C26-9897-DCAAC3225491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9640420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2763F5-226F-465B-BB31-55458F1A20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pt-P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EC3CA7-2B7D-410F-A335-980057A1BF0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t-P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947A79-3724-423C-A506-541849E654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A9F78-BE60-46E7-BF98-1960E6ABC729}" type="datetimeFigureOut">
              <a:rPr lang="pt-PT" smtClean="0"/>
              <a:t>22/02/2021</a:t>
            </a:fld>
            <a:endParaRPr lang="pt-P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0D3B72-7F4B-45F8-8E32-1330B91A53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E272F0-F207-4A14-9F56-F38A2E1E24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2C8B4-FAB2-4C26-9897-DCAAC3225491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0269107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0120AD-1541-403F-954B-13D5B121E4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pt-P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0D37DD-2F7C-4AB5-A0D7-317DE9A48E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E0D77F-82CF-4C46-8BB0-99A3494421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A9F78-BE60-46E7-BF98-1960E6ABC729}" type="datetimeFigureOut">
              <a:rPr lang="pt-PT" smtClean="0"/>
              <a:t>22/02/2021</a:t>
            </a:fld>
            <a:endParaRPr lang="pt-P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307841-D680-4C7E-951A-574E3AE22E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216753-4CC8-446A-B0F5-66CF657110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2C8B4-FAB2-4C26-9897-DCAAC3225491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55283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4F82A0-8E8C-4BDE-8D91-1EFDFB2327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pt-P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C6CBC1A-9885-45FC-9D7D-55D44423173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t-PT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9C7631-6942-4B1F-874F-073110F865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t-PT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E09EB3-C518-4269-998C-9323E2EAD9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A9F78-BE60-46E7-BF98-1960E6ABC729}" type="datetimeFigureOut">
              <a:rPr lang="pt-PT" smtClean="0"/>
              <a:t>22/02/2021</a:t>
            </a:fld>
            <a:endParaRPr lang="pt-P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5A29B7-30CD-4532-BA92-D96C657BCD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6F2EF34-DAF5-4A77-A3C1-DA099F37E9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2C8B4-FAB2-4C26-9897-DCAAC3225491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1813296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EE303F-D631-4EEB-94D6-60377705D0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pt-P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1EBBE1-2A21-44E6-BAF8-53C14BE82D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85B5BB9-56C2-40A8-A94C-8B964FBD33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t-PT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1FE4D04-4722-45A6-8AF7-21E909CF83B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9FDAD62-9C94-45A1-AABA-24E7A2B70C7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t-PT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B3230C8-922B-430F-AA1F-2241739C9C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A9F78-BE60-46E7-BF98-1960E6ABC729}" type="datetimeFigureOut">
              <a:rPr lang="pt-PT" smtClean="0"/>
              <a:t>22/02/2021</a:t>
            </a:fld>
            <a:endParaRPr lang="pt-PT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160C42F-B29F-45F7-86A3-6691BB1506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0BB8031-E750-4233-AA05-873B281DEC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2C8B4-FAB2-4C26-9897-DCAAC3225491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2002637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AE209E-F41A-45CC-8922-79F78206D7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pt-PT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C9B2245-096B-4F81-8C34-62C3637CAC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A9F78-BE60-46E7-BF98-1960E6ABC729}" type="datetimeFigureOut">
              <a:rPr lang="pt-PT" smtClean="0"/>
              <a:t>22/02/2021</a:t>
            </a:fld>
            <a:endParaRPr lang="pt-PT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268419F-5736-4D6F-8854-BD43F37BCA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F41594F-DEFC-4E58-AB94-9089198CB1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2C8B4-FAB2-4C26-9897-DCAAC3225491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7518835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9A8E26A-E322-4B6E-BFF8-67D0039E2F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A9F78-BE60-46E7-BF98-1960E6ABC729}" type="datetimeFigureOut">
              <a:rPr lang="pt-PT" smtClean="0"/>
              <a:t>22/02/2021</a:t>
            </a:fld>
            <a:endParaRPr lang="pt-PT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57DA092-1B88-4E40-8EEB-D639710D40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39647DF-5F3E-4E12-B98C-AF78C0CF41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2C8B4-FAB2-4C26-9897-DCAAC3225491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2696683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6FD1A0-838B-4ACD-AD43-FE781CDC56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pt-P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0B6A7D-5A1F-4DAC-92A6-B235CB219B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t-P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C04B086-47D4-4D77-99F4-B87ED4BEB2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817306-5004-464C-9A82-5C67D16983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A9F78-BE60-46E7-BF98-1960E6ABC729}" type="datetimeFigureOut">
              <a:rPr lang="pt-PT" smtClean="0"/>
              <a:t>22/02/2021</a:t>
            </a:fld>
            <a:endParaRPr lang="pt-P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81F360C-C137-4232-B48E-E3CBCDC1A4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977AEF-BD3E-47DC-BA22-E91983DAF4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2C8B4-FAB2-4C26-9897-DCAAC3225491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4684783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E48ADE-4B78-4E71-8C77-27FAC4EE06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pt-PT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695AC63-F111-483E-A56C-9D62E9835C6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P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B34E96C-8CD5-43B3-8D3B-82FA523489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961FCE2-B3DA-44CD-91F8-B89A4AE1E7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3A9F78-BE60-46E7-BF98-1960E6ABC729}" type="datetimeFigureOut">
              <a:rPr lang="pt-PT" smtClean="0"/>
              <a:t>22/02/2021</a:t>
            </a:fld>
            <a:endParaRPr lang="pt-P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42573EE-4113-4EDD-9784-BE6FD28096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D2E340-79A1-4329-9A16-A979A2BDB8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62C8B4-FAB2-4C26-9897-DCAAC3225491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6492747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626F28F-993A-4186-AF37-D7FD324842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pt-P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77516C-CC32-4B05-85A0-5FE05CAEB5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pt-P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85B2C4-DBC9-4A12-831B-D6F2A43C59B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3A9F78-BE60-46E7-BF98-1960E6ABC729}" type="datetimeFigureOut">
              <a:rPr lang="pt-PT" smtClean="0"/>
              <a:t>22/02/2021</a:t>
            </a:fld>
            <a:endParaRPr lang="pt-P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D5E519-063B-41DF-8408-1EB3A3DC2AD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AB0C24-D50C-42EE-B6E4-45086DCDFD6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62C8B4-FAB2-4C26-9897-DCAAC3225491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5484271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41E8B7A0-B2D2-4122-B217-AF79131B033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40412353"/>
              </p:ext>
            </p:extLst>
          </p:nvPr>
        </p:nvGraphicFramePr>
        <p:xfrm>
          <a:off x="384969" y="0"/>
          <a:ext cx="11159332" cy="61372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5D44AEAA-95E4-4C54-A6E7-AC6D1B669DBC}"/>
              </a:ext>
            </a:extLst>
          </p:cNvPr>
          <p:cNvSpPr txBox="1"/>
          <p:nvPr/>
        </p:nvSpPr>
        <p:spPr>
          <a:xfrm>
            <a:off x="0" y="6211669"/>
            <a:ext cx="12192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b="1" dirty="0" err="1"/>
              <a:t>Supplementary</a:t>
            </a:r>
            <a:r>
              <a:rPr lang="pt-PT" b="1" dirty="0"/>
              <a:t> Figure S3. </a:t>
            </a:r>
            <a:r>
              <a:rPr lang="en-US" dirty="0"/>
              <a:t>Relative abundances of archaeal 16S rRNA genes at genus taxonomic rank. </a:t>
            </a:r>
            <a:r>
              <a:rPr lang="en-US"/>
              <a:t>Legend provides taxonomic classification from domain to genus ranks.</a:t>
            </a:r>
          </a:p>
        </p:txBody>
      </p:sp>
    </p:spTree>
    <p:extLst>
      <p:ext uri="{BB962C8B-B14F-4D97-AF65-F5344CB8AC3E}">
        <p14:creationId xmlns:p14="http://schemas.microsoft.com/office/powerpoint/2010/main" val="14652720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6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gor Clemente Tiago</dc:creator>
  <cp:lastModifiedBy>I T</cp:lastModifiedBy>
  <cp:revision>4</cp:revision>
  <dcterms:created xsi:type="dcterms:W3CDTF">2021-01-27T17:24:22Z</dcterms:created>
  <dcterms:modified xsi:type="dcterms:W3CDTF">2021-02-22T00:30:03Z</dcterms:modified>
</cp:coreProperties>
</file>